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  <p:sldId id="257" r:id="rId4"/>
    <p:sldId id="260" r:id="rId5"/>
    <p:sldId id="258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687F9F5-4B73-4BCD-B806-99043288C9C4}" v="2" dt="2023-02-01T07:41:13.85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43" d="100"/>
          <a:sy n="43" d="100"/>
        </p:scale>
        <p:origin x="2288" y="11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chael Greenwood" userId="add436ed-1825-4a16-a55d-7f910a9607be" providerId="ADAL" clId="{AFC80EFC-91A5-417D-AC42-DF74FA2AA4CD}"/>
    <pc:docChg chg="undo redo custSel addSld delSld modSld sldOrd">
      <pc:chgData name="Michael Greenwood" userId="add436ed-1825-4a16-a55d-7f910a9607be" providerId="ADAL" clId="{AFC80EFC-91A5-417D-AC42-DF74FA2AA4CD}" dt="2023-01-27T13:17:02.062" v="5681" actId="20577"/>
      <pc:docMkLst>
        <pc:docMk/>
      </pc:docMkLst>
      <pc:sldChg chg="addSp delSp modSp mod">
        <pc:chgData name="Michael Greenwood" userId="add436ed-1825-4a16-a55d-7f910a9607be" providerId="ADAL" clId="{AFC80EFC-91A5-417D-AC42-DF74FA2AA4CD}" dt="2023-01-27T13:02:39.439" v="4942" actId="20577"/>
        <pc:sldMkLst>
          <pc:docMk/>
          <pc:sldMk cId="4241183718" sldId="256"/>
        </pc:sldMkLst>
        <pc:spChg chg="add del mod">
          <ac:chgData name="Michael Greenwood" userId="add436ed-1825-4a16-a55d-7f910a9607be" providerId="ADAL" clId="{AFC80EFC-91A5-417D-AC42-DF74FA2AA4CD}" dt="2022-11-07T10:49:51.374" v="2222" actId="478"/>
          <ac:spMkLst>
            <pc:docMk/>
            <pc:sldMk cId="4241183718" sldId="256"/>
            <ac:spMk id="3" creationId="{96A9C324-54E4-99B8-C647-1DD6A6B7EECE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6" creationId="{E7058D93-E8A1-48F1-7746-7E2C34CF291B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7" creationId="{A1AE71D0-8C84-AF45-BD0D-BE66F0060AE4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8" creationId="{7D3E3221-5D24-EE97-802E-ED09772C9723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9" creationId="{3E3AA3BA-C175-FA79-E166-20C6C534957E}"/>
          </ac:spMkLst>
        </pc:spChg>
        <pc:spChg chg="mod">
          <ac:chgData name="Michael Greenwood" userId="add436ed-1825-4a16-a55d-7f910a9607be" providerId="ADAL" clId="{AFC80EFC-91A5-417D-AC42-DF74FA2AA4CD}" dt="2022-11-07T10:20:17.072" v="947" actId="1038"/>
          <ac:spMkLst>
            <pc:docMk/>
            <pc:sldMk cId="4241183718" sldId="256"/>
            <ac:spMk id="10" creationId="{FEF517E4-828D-394D-6E1F-C861BD4136C1}"/>
          </ac:spMkLst>
        </pc:spChg>
        <pc:spChg chg="mod">
          <ac:chgData name="Michael Greenwood" userId="add436ed-1825-4a16-a55d-7f910a9607be" providerId="ADAL" clId="{AFC80EFC-91A5-417D-AC42-DF74FA2AA4CD}" dt="2022-11-07T10:20:07.316" v="936" actId="1038"/>
          <ac:spMkLst>
            <pc:docMk/>
            <pc:sldMk cId="4241183718" sldId="256"/>
            <ac:spMk id="11" creationId="{D60699CF-3BD4-F625-DB76-DA90E4B5DF7F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12" creationId="{9D5E916C-A041-BE65-F4BC-476F874B9685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13" creationId="{79F24294-8E99-36C3-EF8F-E64FB03B1F40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14" creationId="{1B04F410-5849-B7FE-5A6E-DA54B74200A7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15" creationId="{383BD04B-6662-4BAC-994D-885BFF8A2687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16" creationId="{C39334ED-FA17-54AA-2E0E-1D3CAD850B89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17" creationId="{D41984DF-194E-FAE9-81FC-50586588BE2A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18" creationId="{3F03457E-1D4A-E0F2-20FC-B48C9C212647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24" creationId="{B0EC2B44-AA3C-4A68-A062-A8E3D094FF25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25" creationId="{8E812CFA-0765-0164-BFBA-0B0AB6AF3E0D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26" creationId="{3B93F826-A2A2-5099-21AC-F61D5A9C09B2}"/>
          </ac:spMkLst>
        </pc:spChg>
        <pc:spChg chg="mod">
          <ac:chgData name="Michael Greenwood" userId="add436ed-1825-4a16-a55d-7f910a9607be" providerId="ADAL" clId="{AFC80EFC-91A5-417D-AC42-DF74FA2AA4CD}" dt="2022-11-07T09:50:05.609" v="180" actId="1038"/>
          <ac:spMkLst>
            <pc:docMk/>
            <pc:sldMk cId="4241183718" sldId="256"/>
            <ac:spMk id="27" creationId="{5E70B2E9-3482-9BCF-4607-3B8526FDF2A5}"/>
          </ac:spMkLst>
        </pc:spChg>
        <pc:spChg chg="mod">
          <ac:chgData name="Michael Greenwood" userId="add436ed-1825-4a16-a55d-7f910a9607be" providerId="ADAL" clId="{AFC80EFC-91A5-417D-AC42-DF74FA2AA4CD}" dt="2023-01-27T13:02:39.439" v="4942" actId="20577"/>
          <ac:spMkLst>
            <pc:docMk/>
            <pc:sldMk cId="4241183718" sldId="256"/>
            <ac:spMk id="28" creationId="{9C4CF7EA-FA4F-83E4-9B14-680AF1821D47}"/>
          </ac:spMkLst>
        </pc:spChg>
        <pc:picChg chg="mod">
          <ac:chgData name="Michael Greenwood" userId="add436ed-1825-4a16-a55d-7f910a9607be" providerId="ADAL" clId="{AFC80EFC-91A5-417D-AC42-DF74FA2AA4CD}" dt="2022-11-07T09:50:05.609" v="180" actId="1038"/>
          <ac:picMkLst>
            <pc:docMk/>
            <pc:sldMk cId="4241183718" sldId="256"/>
            <ac:picMk id="4" creationId="{0E8CBACE-C65B-AC90-4A67-E24B9F885B5B}"/>
          </ac:picMkLst>
        </pc:picChg>
        <pc:picChg chg="mod">
          <ac:chgData name="Michael Greenwood" userId="add436ed-1825-4a16-a55d-7f910a9607be" providerId="ADAL" clId="{AFC80EFC-91A5-417D-AC42-DF74FA2AA4CD}" dt="2022-11-07T09:50:05.609" v="180" actId="1038"/>
          <ac:picMkLst>
            <pc:docMk/>
            <pc:sldMk cId="4241183718" sldId="256"/>
            <ac:picMk id="5" creationId="{CAE42A47-D469-05FD-8862-5007D73C4FF3}"/>
          </ac:picMkLst>
        </pc:picChg>
        <pc:cxnChg chg="mod">
          <ac:chgData name="Michael Greenwood" userId="add436ed-1825-4a16-a55d-7f910a9607be" providerId="ADAL" clId="{AFC80EFC-91A5-417D-AC42-DF74FA2AA4CD}" dt="2022-11-07T09:50:05.609" v="180" actId="1038"/>
          <ac:cxnSpMkLst>
            <pc:docMk/>
            <pc:sldMk cId="4241183718" sldId="256"/>
            <ac:cxnSpMk id="19" creationId="{03D886AB-ED0E-C908-CEE6-0CABFA2888CE}"/>
          </ac:cxnSpMkLst>
        </pc:cxnChg>
        <pc:cxnChg chg="mod">
          <ac:chgData name="Michael Greenwood" userId="add436ed-1825-4a16-a55d-7f910a9607be" providerId="ADAL" clId="{AFC80EFC-91A5-417D-AC42-DF74FA2AA4CD}" dt="2022-11-07T09:50:05.609" v="180" actId="1038"/>
          <ac:cxnSpMkLst>
            <pc:docMk/>
            <pc:sldMk cId="4241183718" sldId="256"/>
            <ac:cxnSpMk id="20" creationId="{F3598CB5-00D2-2CE3-2F01-702193DDB9EB}"/>
          </ac:cxnSpMkLst>
        </pc:cxnChg>
        <pc:cxnChg chg="mod">
          <ac:chgData name="Michael Greenwood" userId="add436ed-1825-4a16-a55d-7f910a9607be" providerId="ADAL" clId="{AFC80EFC-91A5-417D-AC42-DF74FA2AA4CD}" dt="2022-11-07T09:50:05.609" v="180" actId="1038"/>
          <ac:cxnSpMkLst>
            <pc:docMk/>
            <pc:sldMk cId="4241183718" sldId="256"/>
            <ac:cxnSpMk id="21" creationId="{46F85556-0F0D-68C3-918D-868F3E351012}"/>
          </ac:cxnSpMkLst>
        </pc:cxnChg>
        <pc:cxnChg chg="mod">
          <ac:chgData name="Michael Greenwood" userId="add436ed-1825-4a16-a55d-7f910a9607be" providerId="ADAL" clId="{AFC80EFC-91A5-417D-AC42-DF74FA2AA4CD}" dt="2022-11-07T09:50:05.609" v="180" actId="1038"/>
          <ac:cxnSpMkLst>
            <pc:docMk/>
            <pc:sldMk cId="4241183718" sldId="256"/>
            <ac:cxnSpMk id="22" creationId="{17C831E7-2370-DA14-3931-075DAD144928}"/>
          </ac:cxnSpMkLst>
        </pc:cxnChg>
        <pc:cxnChg chg="mod">
          <ac:chgData name="Michael Greenwood" userId="add436ed-1825-4a16-a55d-7f910a9607be" providerId="ADAL" clId="{AFC80EFC-91A5-417D-AC42-DF74FA2AA4CD}" dt="2022-11-07T09:50:05.609" v="180" actId="1038"/>
          <ac:cxnSpMkLst>
            <pc:docMk/>
            <pc:sldMk cId="4241183718" sldId="256"/>
            <ac:cxnSpMk id="23" creationId="{518CA005-95D0-CCA1-91DE-69634DCB342A}"/>
          </ac:cxnSpMkLst>
        </pc:cxnChg>
      </pc:sldChg>
      <pc:sldChg chg="addSp delSp modSp new mod">
        <pc:chgData name="Michael Greenwood" userId="add436ed-1825-4a16-a55d-7f910a9607be" providerId="ADAL" clId="{AFC80EFC-91A5-417D-AC42-DF74FA2AA4CD}" dt="2023-01-27T13:05:12.114" v="5151" actId="1076"/>
        <pc:sldMkLst>
          <pc:docMk/>
          <pc:sldMk cId="3066318947" sldId="257"/>
        </pc:sldMkLst>
        <pc:spChg chg="add mod">
          <ac:chgData name="Michael Greenwood" userId="add436ed-1825-4a16-a55d-7f910a9607be" providerId="ADAL" clId="{AFC80EFC-91A5-417D-AC42-DF74FA2AA4CD}" dt="2022-11-07T10:58:39.057" v="2423" actId="1037"/>
          <ac:spMkLst>
            <pc:docMk/>
            <pc:sldMk cId="3066318947" sldId="257"/>
            <ac:spMk id="4" creationId="{F4D55758-CE9D-52DB-5FA9-0511D59BC172}"/>
          </ac:spMkLst>
        </pc:spChg>
        <pc:spChg chg="add mod">
          <ac:chgData name="Michael Greenwood" userId="add436ed-1825-4a16-a55d-7f910a9607be" providerId="ADAL" clId="{AFC80EFC-91A5-417D-AC42-DF74FA2AA4CD}" dt="2022-11-07T11:08:52.065" v="2907" actId="1037"/>
          <ac:spMkLst>
            <pc:docMk/>
            <pc:sldMk cId="3066318947" sldId="257"/>
            <ac:spMk id="5" creationId="{4FB12F9B-4BD2-1C50-C989-748F12815A2D}"/>
          </ac:spMkLst>
        </pc:spChg>
        <pc:spChg chg="add mod">
          <ac:chgData name="Michael Greenwood" userId="add436ed-1825-4a16-a55d-7f910a9607be" providerId="ADAL" clId="{AFC80EFC-91A5-417D-AC42-DF74FA2AA4CD}" dt="2022-11-07T10:58:39.057" v="2423" actId="1037"/>
          <ac:spMkLst>
            <pc:docMk/>
            <pc:sldMk cId="3066318947" sldId="257"/>
            <ac:spMk id="6" creationId="{2F6A343A-9EAF-5EF1-C0D9-BBF270F23FBD}"/>
          </ac:spMkLst>
        </pc:spChg>
        <pc:spChg chg="add mod">
          <ac:chgData name="Michael Greenwood" userId="add436ed-1825-4a16-a55d-7f910a9607be" providerId="ADAL" clId="{AFC80EFC-91A5-417D-AC42-DF74FA2AA4CD}" dt="2022-11-07T10:58:39.057" v="2423" actId="1037"/>
          <ac:spMkLst>
            <pc:docMk/>
            <pc:sldMk cId="3066318947" sldId="257"/>
            <ac:spMk id="7" creationId="{5187D226-1639-6D53-1645-93D5FD93FD9E}"/>
          </ac:spMkLst>
        </pc:spChg>
        <pc:spChg chg="add mod">
          <ac:chgData name="Michael Greenwood" userId="add436ed-1825-4a16-a55d-7f910a9607be" providerId="ADAL" clId="{AFC80EFC-91A5-417D-AC42-DF74FA2AA4CD}" dt="2022-11-07T10:58:47.181" v="2424" actId="1076"/>
          <ac:spMkLst>
            <pc:docMk/>
            <pc:sldMk cId="3066318947" sldId="257"/>
            <ac:spMk id="8" creationId="{F820BC6F-A182-6892-68C7-A2A0020B2A77}"/>
          </ac:spMkLst>
        </pc:spChg>
        <pc:spChg chg="add mod">
          <ac:chgData name="Michael Greenwood" userId="add436ed-1825-4a16-a55d-7f910a9607be" providerId="ADAL" clId="{AFC80EFC-91A5-417D-AC42-DF74FA2AA4CD}" dt="2023-01-27T13:05:12.114" v="5151" actId="1076"/>
          <ac:spMkLst>
            <pc:docMk/>
            <pc:sldMk cId="3066318947" sldId="257"/>
            <ac:spMk id="9" creationId="{7348D1F2-A041-D925-BCEC-0C4F828257B8}"/>
          </ac:spMkLst>
        </pc:spChg>
        <pc:spChg chg="add mod">
          <ac:chgData name="Michael Greenwood" userId="add436ed-1825-4a16-a55d-7f910a9607be" providerId="ADAL" clId="{AFC80EFC-91A5-417D-AC42-DF74FA2AA4CD}" dt="2022-11-07T13:02:29.287" v="3361" actId="1037"/>
          <ac:spMkLst>
            <pc:docMk/>
            <pc:sldMk cId="3066318947" sldId="257"/>
            <ac:spMk id="11" creationId="{645C6563-173A-8E60-C6BE-BE997C48837E}"/>
          </ac:spMkLst>
        </pc:spChg>
        <pc:spChg chg="add mod">
          <ac:chgData name="Michael Greenwood" userId="add436ed-1825-4a16-a55d-7f910a9607be" providerId="ADAL" clId="{AFC80EFC-91A5-417D-AC42-DF74FA2AA4CD}" dt="2022-11-07T13:02:37.362" v="3389" actId="1038"/>
          <ac:spMkLst>
            <pc:docMk/>
            <pc:sldMk cId="3066318947" sldId="257"/>
            <ac:spMk id="12" creationId="{BF82B2E3-5146-B5B8-FF5B-10D3EC15A040}"/>
          </ac:spMkLst>
        </pc:spChg>
        <pc:spChg chg="add mod">
          <ac:chgData name="Michael Greenwood" userId="add436ed-1825-4a16-a55d-7f910a9607be" providerId="ADAL" clId="{AFC80EFC-91A5-417D-AC42-DF74FA2AA4CD}" dt="2022-11-07T12:53:13.547" v="3259" actId="1038"/>
          <ac:spMkLst>
            <pc:docMk/>
            <pc:sldMk cId="3066318947" sldId="257"/>
            <ac:spMk id="15" creationId="{4BD149A8-0EDA-5CC7-ADA5-C5C1C609A026}"/>
          </ac:spMkLst>
        </pc:spChg>
        <pc:spChg chg="add mod">
          <ac:chgData name="Michael Greenwood" userId="add436ed-1825-4a16-a55d-7f910a9607be" providerId="ADAL" clId="{AFC80EFC-91A5-417D-AC42-DF74FA2AA4CD}" dt="2023-01-27T13:04:07.377" v="5025" actId="1076"/>
          <ac:spMkLst>
            <pc:docMk/>
            <pc:sldMk cId="3066318947" sldId="257"/>
            <ac:spMk id="19" creationId="{60D32C72-1995-C70C-14BC-0EECAF54688B}"/>
          </ac:spMkLst>
        </pc:spChg>
        <pc:spChg chg="add mod">
          <ac:chgData name="Michael Greenwood" userId="add436ed-1825-4a16-a55d-7f910a9607be" providerId="ADAL" clId="{AFC80EFC-91A5-417D-AC42-DF74FA2AA4CD}" dt="2022-11-07T13:03:51.457" v="3617" actId="1037"/>
          <ac:spMkLst>
            <pc:docMk/>
            <pc:sldMk cId="3066318947" sldId="257"/>
            <ac:spMk id="20" creationId="{919E0F96-D834-54A4-1CF8-9FA9478D6D7F}"/>
          </ac:spMkLst>
        </pc:spChg>
        <pc:spChg chg="add del mod">
          <ac:chgData name="Michael Greenwood" userId="add436ed-1825-4a16-a55d-7f910a9607be" providerId="ADAL" clId="{AFC80EFC-91A5-417D-AC42-DF74FA2AA4CD}" dt="2022-11-11T14:23:56.871" v="3911" actId="478"/>
          <ac:spMkLst>
            <pc:docMk/>
            <pc:sldMk cId="3066318947" sldId="257"/>
            <ac:spMk id="21" creationId="{CD523FD1-B02B-08D3-6495-31847236DF5B}"/>
          </ac:spMkLst>
        </pc:spChg>
        <pc:spChg chg="add mod">
          <ac:chgData name="Michael Greenwood" userId="add436ed-1825-4a16-a55d-7f910a9607be" providerId="ADAL" clId="{AFC80EFC-91A5-417D-AC42-DF74FA2AA4CD}" dt="2022-11-11T14:35:01.660" v="4311" actId="1035"/>
          <ac:spMkLst>
            <pc:docMk/>
            <pc:sldMk cId="3066318947" sldId="257"/>
            <ac:spMk id="28" creationId="{AB50DBCD-6446-9A99-C617-3DE34350A72A}"/>
          </ac:spMkLst>
        </pc:spChg>
        <pc:spChg chg="add mod">
          <ac:chgData name="Michael Greenwood" userId="add436ed-1825-4a16-a55d-7f910a9607be" providerId="ADAL" clId="{AFC80EFC-91A5-417D-AC42-DF74FA2AA4CD}" dt="2022-11-11T14:35:01.660" v="4311" actId="1035"/>
          <ac:spMkLst>
            <pc:docMk/>
            <pc:sldMk cId="3066318947" sldId="257"/>
            <ac:spMk id="29" creationId="{FFB7C47A-B5B6-7A48-DB7E-F9E63E2AF8DC}"/>
          </ac:spMkLst>
        </pc:spChg>
        <pc:spChg chg="add mod">
          <ac:chgData name="Michael Greenwood" userId="add436ed-1825-4a16-a55d-7f910a9607be" providerId="ADAL" clId="{AFC80EFC-91A5-417D-AC42-DF74FA2AA4CD}" dt="2022-11-11T14:38:41.858" v="4333" actId="20577"/>
          <ac:spMkLst>
            <pc:docMk/>
            <pc:sldMk cId="3066318947" sldId="257"/>
            <ac:spMk id="35" creationId="{E236AD1A-8636-5115-574E-6A1097FFC635}"/>
          </ac:spMkLst>
        </pc:spChg>
        <pc:spChg chg="add mod">
          <ac:chgData name="Michael Greenwood" userId="add436ed-1825-4a16-a55d-7f910a9607be" providerId="ADAL" clId="{AFC80EFC-91A5-417D-AC42-DF74FA2AA4CD}" dt="2022-11-11T14:39:01.987" v="4404" actId="20577"/>
          <ac:spMkLst>
            <pc:docMk/>
            <pc:sldMk cId="3066318947" sldId="257"/>
            <ac:spMk id="36" creationId="{AE93C186-E353-EDFD-7FE8-5A43D473A925}"/>
          </ac:spMkLst>
        </pc:spChg>
        <pc:spChg chg="add mod">
          <ac:chgData name="Michael Greenwood" userId="add436ed-1825-4a16-a55d-7f910a9607be" providerId="ADAL" clId="{AFC80EFC-91A5-417D-AC42-DF74FA2AA4CD}" dt="2022-11-11T14:41:04.727" v="4541" actId="1038"/>
          <ac:spMkLst>
            <pc:docMk/>
            <pc:sldMk cId="3066318947" sldId="257"/>
            <ac:spMk id="42" creationId="{B32023B0-7B86-04A4-C856-B3D96DB7E8CC}"/>
          </ac:spMkLst>
        </pc:spChg>
        <pc:spChg chg="add mod">
          <ac:chgData name="Michael Greenwood" userId="add436ed-1825-4a16-a55d-7f910a9607be" providerId="ADAL" clId="{AFC80EFC-91A5-417D-AC42-DF74FA2AA4CD}" dt="2022-11-11T14:41:34.664" v="4671" actId="1038"/>
          <ac:spMkLst>
            <pc:docMk/>
            <pc:sldMk cId="3066318947" sldId="257"/>
            <ac:spMk id="43" creationId="{30D6D91A-6449-63FE-3BB3-D951B16E903C}"/>
          </ac:spMkLst>
        </pc:spChg>
        <pc:grpChg chg="add del mod">
          <ac:chgData name="Michael Greenwood" userId="add436ed-1825-4a16-a55d-7f910a9607be" providerId="ADAL" clId="{AFC80EFC-91A5-417D-AC42-DF74FA2AA4CD}" dt="2022-11-11T14:26:25.697" v="4104" actId="165"/>
          <ac:grpSpMkLst>
            <pc:docMk/>
            <pc:sldMk cId="3066318947" sldId="257"/>
            <ac:grpSpMk id="26" creationId="{C98275EF-B5A4-7D48-B0EF-70DF65172B8D}"/>
          </ac:grpSpMkLst>
        </pc:grpChg>
        <pc:grpChg chg="add mod">
          <ac:chgData name="Michael Greenwood" userId="add436ed-1825-4a16-a55d-7f910a9607be" providerId="ADAL" clId="{AFC80EFC-91A5-417D-AC42-DF74FA2AA4CD}" dt="2022-11-11T14:35:01.660" v="4311" actId="1035"/>
          <ac:grpSpMkLst>
            <pc:docMk/>
            <pc:sldMk cId="3066318947" sldId="257"/>
            <ac:grpSpMk id="27" creationId="{29D983B4-40B7-2F5E-F031-6393B1A32368}"/>
          </ac:grpSpMkLst>
        </pc:grpChg>
        <pc:graphicFrameChg chg="add del mod">
          <ac:chgData name="Michael Greenwood" userId="add436ed-1825-4a16-a55d-7f910a9607be" providerId="ADAL" clId="{AFC80EFC-91A5-417D-AC42-DF74FA2AA4CD}" dt="2022-11-07T13:00:02.871" v="3280" actId="478"/>
          <ac:graphicFrameMkLst>
            <pc:docMk/>
            <pc:sldMk cId="3066318947" sldId="257"/>
            <ac:graphicFrameMk id="13" creationId="{E56B145B-FB55-563C-D1DE-2690B16AEF40}"/>
          </ac:graphicFrameMkLst>
        </pc:graphicFrameChg>
        <pc:graphicFrameChg chg="add del mod">
          <ac:chgData name="Michael Greenwood" userId="add436ed-1825-4a16-a55d-7f910a9607be" providerId="ADAL" clId="{AFC80EFC-91A5-417D-AC42-DF74FA2AA4CD}" dt="2022-11-07T12:59:51.572" v="3262" actId="478"/>
          <ac:graphicFrameMkLst>
            <pc:docMk/>
            <pc:sldMk cId="3066318947" sldId="257"/>
            <ac:graphicFrameMk id="14" creationId="{4888CE3A-C70B-77DD-14A1-095C95433E29}"/>
          </ac:graphicFrameMkLst>
        </pc:graphicFrameChg>
        <pc:graphicFrameChg chg="add mod">
          <ac:chgData name="Michael Greenwood" userId="add436ed-1825-4a16-a55d-7f910a9607be" providerId="ADAL" clId="{AFC80EFC-91A5-417D-AC42-DF74FA2AA4CD}" dt="2022-11-11T14:38:29.316" v="4330" actId="1076"/>
          <ac:graphicFrameMkLst>
            <pc:docMk/>
            <pc:sldMk cId="3066318947" sldId="257"/>
            <ac:graphicFrameMk id="16" creationId="{820897DA-E7C7-2F83-DB32-19C84B0F9E48}"/>
          </ac:graphicFrameMkLst>
        </pc:graphicFrameChg>
        <pc:graphicFrameChg chg="add mod">
          <ac:chgData name="Michael Greenwood" userId="add436ed-1825-4a16-a55d-7f910a9607be" providerId="ADAL" clId="{AFC80EFC-91A5-417D-AC42-DF74FA2AA4CD}" dt="2022-11-07T13:03:44.837" v="3601" actId="1036"/>
          <ac:graphicFrameMkLst>
            <pc:docMk/>
            <pc:sldMk cId="3066318947" sldId="257"/>
            <ac:graphicFrameMk id="17" creationId="{59A8BE11-E17E-40B9-ABE0-B665DA9BD022}"/>
          </ac:graphicFrameMkLst>
        </pc:graphicFrameChg>
        <pc:graphicFrameChg chg="add del mod">
          <ac:chgData name="Michael Greenwood" userId="add436ed-1825-4a16-a55d-7f910a9607be" providerId="ADAL" clId="{AFC80EFC-91A5-417D-AC42-DF74FA2AA4CD}" dt="2022-11-11T14:38:08.882" v="4326" actId="478"/>
          <ac:graphicFrameMkLst>
            <pc:docMk/>
            <pc:sldMk cId="3066318947" sldId="257"/>
            <ac:graphicFrameMk id="30" creationId="{993FE541-FDAA-6815-FC81-00C1CAB8FDEA}"/>
          </ac:graphicFrameMkLst>
        </pc:graphicFrameChg>
        <pc:graphicFrameChg chg="add del mod">
          <ac:chgData name="Michael Greenwood" userId="add436ed-1825-4a16-a55d-7f910a9607be" providerId="ADAL" clId="{AFC80EFC-91A5-417D-AC42-DF74FA2AA4CD}" dt="2022-11-11T14:38:11.134" v="4327" actId="478"/>
          <ac:graphicFrameMkLst>
            <pc:docMk/>
            <pc:sldMk cId="3066318947" sldId="257"/>
            <ac:graphicFrameMk id="31" creationId="{8041EBE3-C0C4-0BD1-556E-4F00B336B2B4}"/>
          </ac:graphicFrameMkLst>
        </pc:graphicFrameChg>
        <pc:graphicFrameChg chg="add mod">
          <ac:chgData name="Michael Greenwood" userId="add436ed-1825-4a16-a55d-7f910a9607be" providerId="ADAL" clId="{AFC80EFC-91A5-417D-AC42-DF74FA2AA4CD}" dt="2022-11-11T14:39:10.197" v="4412" actId="1036"/>
          <ac:graphicFrameMkLst>
            <pc:docMk/>
            <pc:sldMk cId="3066318947" sldId="257"/>
            <ac:graphicFrameMk id="32" creationId="{CB410EAB-E640-08A9-BE56-D48C3A03199E}"/>
          </ac:graphicFrameMkLst>
        </pc:graphicFrameChg>
        <pc:graphicFrameChg chg="add del mod">
          <ac:chgData name="Michael Greenwood" userId="add436ed-1825-4a16-a55d-7f910a9607be" providerId="ADAL" clId="{AFC80EFC-91A5-417D-AC42-DF74FA2AA4CD}" dt="2022-11-11T14:37:03.244" v="4318" actId="478"/>
          <ac:graphicFrameMkLst>
            <pc:docMk/>
            <pc:sldMk cId="3066318947" sldId="257"/>
            <ac:graphicFrameMk id="33" creationId="{0AACC6ED-25E2-B8D5-FE10-8623259AA33A}"/>
          </ac:graphicFrameMkLst>
        </pc:graphicFrameChg>
        <pc:graphicFrameChg chg="add mod">
          <ac:chgData name="Michael Greenwood" userId="add436ed-1825-4a16-a55d-7f910a9607be" providerId="ADAL" clId="{AFC80EFC-91A5-417D-AC42-DF74FA2AA4CD}" dt="2022-11-11T14:39:10.197" v="4412" actId="1036"/>
          <ac:graphicFrameMkLst>
            <pc:docMk/>
            <pc:sldMk cId="3066318947" sldId="257"/>
            <ac:graphicFrameMk id="34" creationId="{054EB029-5B45-E9C9-6123-FBF7925B33DD}"/>
          </ac:graphicFrameMkLst>
        </pc:graphicFrameChg>
        <pc:picChg chg="add mod">
          <ac:chgData name="Michael Greenwood" userId="add436ed-1825-4a16-a55d-7f910a9607be" providerId="ADAL" clId="{AFC80EFC-91A5-417D-AC42-DF74FA2AA4CD}" dt="2022-11-07T10:58:39.057" v="2423" actId="1037"/>
          <ac:picMkLst>
            <pc:docMk/>
            <pc:sldMk cId="3066318947" sldId="257"/>
            <ac:picMk id="2" creationId="{1941EE88-2312-90B6-84B8-1D32BC27C993}"/>
          </ac:picMkLst>
        </pc:picChg>
        <pc:picChg chg="add mod">
          <ac:chgData name="Michael Greenwood" userId="add436ed-1825-4a16-a55d-7f910a9607be" providerId="ADAL" clId="{AFC80EFC-91A5-417D-AC42-DF74FA2AA4CD}" dt="2022-11-07T10:58:39.057" v="2423" actId="1037"/>
          <ac:picMkLst>
            <pc:docMk/>
            <pc:sldMk cId="3066318947" sldId="257"/>
            <ac:picMk id="3" creationId="{EE0B6A2F-305C-E1D5-9FF3-10FB403E699B}"/>
          </ac:picMkLst>
        </pc:picChg>
        <pc:picChg chg="add del mod">
          <ac:chgData name="Michael Greenwood" userId="add436ed-1825-4a16-a55d-7f910a9607be" providerId="ADAL" clId="{AFC80EFC-91A5-417D-AC42-DF74FA2AA4CD}" dt="2022-11-07T13:01:53.791" v="3322" actId="478"/>
          <ac:picMkLst>
            <pc:docMk/>
            <pc:sldMk cId="3066318947" sldId="257"/>
            <ac:picMk id="10" creationId="{19B81AB0-6E67-BDF6-9CDA-744D72902833}"/>
          </ac:picMkLst>
        </pc:picChg>
        <pc:picChg chg="add mod">
          <ac:chgData name="Michael Greenwood" userId="add436ed-1825-4a16-a55d-7f910a9607be" providerId="ADAL" clId="{AFC80EFC-91A5-417D-AC42-DF74FA2AA4CD}" dt="2022-11-07T13:02:19.999" v="3325" actId="1076"/>
          <ac:picMkLst>
            <pc:docMk/>
            <pc:sldMk cId="3066318947" sldId="257"/>
            <ac:picMk id="18" creationId="{16EC6F89-1B5E-921D-E306-FE55EB4D61D5}"/>
          </ac:picMkLst>
        </pc:picChg>
        <pc:picChg chg="add mod">
          <ac:chgData name="Michael Greenwood" userId="add436ed-1825-4a16-a55d-7f910a9607be" providerId="ADAL" clId="{AFC80EFC-91A5-417D-AC42-DF74FA2AA4CD}" dt="2022-11-11T14:25:41.904" v="4098" actId="1036"/>
          <ac:picMkLst>
            <pc:docMk/>
            <pc:sldMk cId="3066318947" sldId="257"/>
            <ac:picMk id="22" creationId="{F1D76F69-0347-C9E8-074E-CBDC987ED0F2}"/>
          </ac:picMkLst>
        </pc:picChg>
        <pc:picChg chg="add mod">
          <ac:chgData name="Michael Greenwood" userId="add436ed-1825-4a16-a55d-7f910a9607be" providerId="ADAL" clId="{AFC80EFC-91A5-417D-AC42-DF74FA2AA4CD}" dt="2022-11-11T14:25:41.904" v="4098" actId="1036"/>
          <ac:picMkLst>
            <pc:docMk/>
            <pc:sldMk cId="3066318947" sldId="257"/>
            <ac:picMk id="23" creationId="{B9FCFCF4-FCB0-7DD5-A8C0-B78E0BDB36A4}"/>
          </ac:picMkLst>
        </pc:picChg>
        <pc:picChg chg="add mod topLvl">
          <ac:chgData name="Michael Greenwood" userId="add436ed-1825-4a16-a55d-7f910a9607be" providerId="ADAL" clId="{AFC80EFC-91A5-417D-AC42-DF74FA2AA4CD}" dt="2022-11-11T14:26:38.844" v="4118" actId="164"/>
          <ac:picMkLst>
            <pc:docMk/>
            <pc:sldMk cId="3066318947" sldId="257"/>
            <ac:picMk id="24" creationId="{335E3CB9-669A-DD69-20EA-D3212791C94D}"/>
          </ac:picMkLst>
        </pc:picChg>
        <pc:picChg chg="add mod topLvl">
          <ac:chgData name="Michael Greenwood" userId="add436ed-1825-4a16-a55d-7f910a9607be" providerId="ADAL" clId="{AFC80EFC-91A5-417D-AC42-DF74FA2AA4CD}" dt="2022-11-11T14:26:38.844" v="4118" actId="164"/>
          <ac:picMkLst>
            <pc:docMk/>
            <pc:sldMk cId="3066318947" sldId="257"/>
            <ac:picMk id="25" creationId="{71E2B6FC-01B0-932A-52F0-ACF5EC6E1DAE}"/>
          </ac:picMkLst>
        </pc:picChg>
        <pc:cxnChg chg="add del mod">
          <ac:chgData name="Michael Greenwood" userId="add436ed-1825-4a16-a55d-7f910a9607be" providerId="ADAL" clId="{AFC80EFC-91A5-417D-AC42-DF74FA2AA4CD}" dt="2022-11-11T14:39:41.469" v="4414" actId="11529"/>
          <ac:cxnSpMkLst>
            <pc:docMk/>
            <pc:sldMk cId="3066318947" sldId="257"/>
            <ac:cxnSpMk id="38" creationId="{809C08FD-4C14-2191-6413-20D2F0D71430}"/>
          </ac:cxnSpMkLst>
        </pc:cxnChg>
        <pc:cxnChg chg="add mod">
          <ac:chgData name="Michael Greenwood" userId="add436ed-1825-4a16-a55d-7f910a9607be" providerId="ADAL" clId="{AFC80EFC-91A5-417D-AC42-DF74FA2AA4CD}" dt="2022-11-11T14:40:09.254" v="4438" actId="1036"/>
          <ac:cxnSpMkLst>
            <pc:docMk/>
            <pc:sldMk cId="3066318947" sldId="257"/>
            <ac:cxnSpMk id="40" creationId="{3ECFF91C-A859-F56B-C6E2-5EF5D4212A77}"/>
          </ac:cxnSpMkLst>
        </pc:cxnChg>
        <pc:cxnChg chg="add mod">
          <ac:chgData name="Michael Greenwood" userId="add436ed-1825-4a16-a55d-7f910a9607be" providerId="ADAL" clId="{AFC80EFC-91A5-417D-AC42-DF74FA2AA4CD}" dt="2022-11-11T14:40:22.752" v="4502" actId="1037"/>
          <ac:cxnSpMkLst>
            <pc:docMk/>
            <pc:sldMk cId="3066318947" sldId="257"/>
            <ac:cxnSpMk id="41" creationId="{8B8BACA7-D64E-E773-BFE8-921B291E7EF0}"/>
          </ac:cxnSpMkLst>
        </pc:cxnChg>
      </pc:sldChg>
      <pc:sldChg chg="addSp modSp new mod ord">
        <pc:chgData name="Michael Greenwood" userId="add436ed-1825-4a16-a55d-7f910a9607be" providerId="ADAL" clId="{AFC80EFC-91A5-417D-AC42-DF74FA2AA4CD}" dt="2023-01-27T13:03:24.394" v="4949" actId="20577"/>
        <pc:sldMkLst>
          <pc:docMk/>
          <pc:sldMk cId="3552318196" sldId="258"/>
        </pc:sldMkLst>
        <pc:spChg chg="add mod">
          <ac:chgData name="Michael Greenwood" userId="add436ed-1825-4a16-a55d-7f910a9607be" providerId="ADAL" clId="{AFC80EFC-91A5-417D-AC42-DF74FA2AA4CD}" dt="2023-01-27T13:03:24.394" v="4949" actId="20577"/>
          <ac:spMkLst>
            <pc:docMk/>
            <pc:sldMk cId="3552318196" sldId="258"/>
            <ac:spMk id="3" creationId="{1AB103E8-84D1-C8CF-D253-ADA40AFB17E7}"/>
          </ac:spMkLst>
        </pc:spChg>
        <pc:graphicFrameChg chg="add mod">
          <ac:chgData name="Michael Greenwood" userId="add436ed-1825-4a16-a55d-7f910a9607be" providerId="ADAL" clId="{AFC80EFC-91A5-417D-AC42-DF74FA2AA4CD}" dt="2022-09-30T09:10:37.993" v="64" actId="1076"/>
          <ac:graphicFrameMkLst>
            <pc:docMk/>
            <pc:sldMk cId="3552318196" sldId="258"/>
            <ac:graphicFrameMk id="2" creationId="{F367482E-ACD8-8219-C0C8-0331A463AC9D}"/>
          </ac:graphicFrameMkLst>
        </pc:graphicFrameChg>
      </pc:sldChg>
      <pc:sldChg chg="addSp modSp new mod ord">
        <pc:chgData name="Michael Greenwood" userId="add436ed-1825-4a16-a55d-7f910a9607be" providerId="ADAL" clId="{AFC80EFC-91A5-417D-AC42-DF74FA2AA4CD}" dt="2023-01-27T13:02:47.834" v="4944" actId="20577"/>
        <pc:sldMkLst>
          <pc:docMk/>
          <pc:sldMk cId="2762088274" sldId="259"/>
        </pc:sldMkLst>
        <pc:spChg chg="add mod">
          <ac:chgData name="Michael Greenwood" userId="add436ed-1825-4a16-a55d-7f910a9607be" providerId="ADAL" clId="{AFC80EFC-91A5-417D-AC42-DF74FA2AA4CD}" dt="2023-01-27T13:02:47.834" v="4944" actId="20577"/>
          <ac:spMkLst>
            <pc:docMk/>
            <pc:sldMk cId="2762088274" sldId="259"/>
            <ac:spMk id="4" creationId="{C7EC6739-B464-FE98-BEF9-BA6442BD8699}"/>
          </ac:spMkLst>
        </pc:spChg>
        <pc:picChg chg="add mod">
          <ac:chgData name="Michael Greenwood" userId="add436ed-1825-4a16-a55d-7f910a9607be" providerId="ADAL" clId="{AFC80EFC-91A5-417D-AC42-DF74FA2AA4CD}" dt="2023-01-27T12:01:45.461" v="4753" actId="1035"/>
          <ac:picMkLst>
            <pc:docMk/>
            <pc:sldMk cId="2762088274" sldId="259"/>
            <ac:picMk id="2" creationId="{9CF591DD-C21C-BD3C-ED80-0DE60EF8B2D6}"/>
          </ac:picMkLst>
        </pc:picChg>
      </pc:sldChg>
      <pc:sldChg chg="addSp delSp modSp new del mod">
        <pc:chgData name="Michael Greenwood" userId="add436ed-1825-4a16-a55d-7f910a9607be" providerId="ADAL" clId="{AFC80EFC-91A5-417D-AC42-DF74FA2AA4CD}" dt="2022-11-07T13:52:15.051" v="3862" actId="2696"/>
        <pc:sldMkLst>
          <pc:docMk/>
          <pc:sldMk cId="3201675004" sldId="259"/>
        </pc:sldMkLst>
        <pc:spChg chg="add del mod">
          <ac:chgData name="Michael Greenwood" userId="add436ed-1825-4a16-a55d-7f910a9607be" providerId="ADAL" clId="{AFC80EFC-91A5-417D-AC42-DF74FA2AA4CD}" dt="2022-11-07T13:47:54.714" v="3755" actId="21"/>
          <ac:spMkLst>
            <pc:docMk/>
            <pc:sldMk cId="3201675004" sldId="259"/>
            <ac:spMk id="4" creationId="{9441C3C0-E7E4-6769-BF98-3C0FBB9F4B78}"/>
          </ac:spMkLst>
        </pc:spChg>
        <pc:graphicFrameChg chg="add del mod">
          <ac:chgData name="Michael Greenwood" userId="add436ed-1825-4a16-a55d-7f910a9607be" providerId="ADAL" clId="{AFC80EFC-91A5-417D-AC42-DF74FA2AA4CD}" dt="2022-11-07T13:52:10.869" v="3861" actId="478"/>
          <ac:graphicFrameMkLst>
            <pc:docMk/>
            <pc:sldMk cId="3201675004" sldId="259"/>
            <ac:graphicFrameMk id="2" creationId="{1D90156B-98D7-0F83-86D9-30717DEE568C}"/>
          </ac:graphicFrameMkLst>
        </pc:graphicFrameChg>
        <pc:graphicFrameChg chg="add del mod">
          <ac:chgData name="Michael Greenwood" userId="add436ed-1825-4a16-a55d-7f910a9607be" providerId="ADAL" clId="{AFC80EFC-91A5-417D-AC42-DF74FA2AA4CD}" dt="2022-11-07T13:52:09.261" v="3860" actId="478"/>
          <ac:graphicFrameMkLst>
            <pc:docMk/>
            <pc:sldMk cId="3201675004" sldId="259"/>
            <ac:graphicFrameMk id="3" creationId="{BEE932E3-69DC-26E7-60BC-6F602307283F}"/>
          </ac:graphicFrameMkLst>
        </pc:graphicFrameChg>
      </pc:sldChg>
      <pc:sldChg chg="addSp modSp new mod ord">
        <pc:chgData name="Michael Greenwood" userId="add436ed-1825-4a16-a55d-7f910a9607be" providerId="ADAL" clId="{AFC80EFC-91A5-417D-AC42-DF74FA2AA4CD}" dt="2023-01-27T13:17:02.062" v="5681" actId="20577"/>
        <pc:sldMkLst>
          <pc:docMk/>
          <pc:sldMk cId="944541349" sldId="260"/>
        </pc:sldMkLst>
        <pc:spChg chg="add mod">
          <ac:chgData name="Michael Greenwood" userId="add436ed-1825-4a16-a55d-7f910a9607be" providerId="ADAL" clId="{AFC80EFC-91A5-417D-AC42-DF74FA2AA4CD}" dt="2023-01-27T13:04:19.313" v="5072" actId="1036"/>
          <ac:spMkLst>
            <pc:docMk/>
            <pc:sldMk cId="944541349" sldId="260"/>
            <ac:spMk id="3" creationId="{2C7DEDAE-8AB8-C7C5-7FC1-DD103E272E99}"/>
          </ac:spMkLst>
        </pc:spChg>
        <pc:spChg chg="add mod">
          <ac:chgData name="Michael Greenwood" userId="add436ed-1825-4a16-a55d-7f910a9607be" providerId="ADAL" clId="{AFC80EFC-91A5-417D-AC42-DF74FA2AA4CD}" dt="2023-01-27T13:04:39.150" v="5150" actId="20577"/>
          <ac:spMkLst>
            <pc:docMk/>
            <pc:sldMk cId="944541349" sldId="260"/>
            <ac:spMk id="4" creationId="{73499D10-BF4A-DF80-271D-A1386A544ADC}"/>
          </ac:spMkLst>
        </pc:spChg>
        <pc:spChg chg="add mod">
          <ac:chgData name="Michael Greenwood" userId="add436ed-1825-4a16-a55d-7f910a9607be" providerId="ADAL" clId="{AFC80EFC-91A5-417D-AC42-DF74FA2AA4CD}" dt="2023-01-27T13:17:02.062" v="5681" actId="20577"/>
          <ac:spMkLst>
            <pc:docMk/>
            <pc:sldMk cId="944541349" sldId="260"/>
            <ac:spMk id="5" creationId="{9040E621-F0B4-5ECD-7053-D1D714A1D191}"/>
          </ac:spMkLst>
        </pc:spChg>
        <pc:picChg chg="mod">
          <ac:chgData name="Michael Greenwood" userId="add436ed-1825-4a16-a55d-7f910a9607be" providerId="ADAL" clId="{AFC80EFC-91A5-417D-AC42-DF74FA2AA4CD}" dt="2023-01-27T13:03:59.833" v="5024" actId="1036"/>
          <ac:picMkLst>
            <pc:docMk/>
            <pc:sldMk cId="944541349" sldId="260"/>
            <ac:picMk id="2" creationId="{0D240DA4-F30F-38AE-E701-04A74495CCA0}"/>
          </ac:picMkLst>
        </pc:picChg>
      </pc:sldChg>
      <pc:sldChg chg="new del">
        <pc:chgData name="Michael Greenwood" userId="add436ed-1825-4a16-a55d-7f910a9607be" providerId="ADAL" clId="{AFC80EFC-91A5-417D-AC42-DF74FA2AA4CD}" dt="2022-11-07T13:52:18.663" v="3863" actId="2696"/>
        <pc:sldMkLst>
          <pc:docMk/>
          <pc:sldMk cId="1022804231" sldId="260"/>
        </pc:sldMkLst>
      </pc:sldChg>
    </pc:docChg>
  </pc:docChgLst>
  <pc:docChgLst>
    <pc:chgData name="Michael Greenwood" userId="add436ed-1825-4a16-a55d-7f910a9607be" providerId="ADAL" clId="{D687F9F5-4B73-4BCD-B806-99043288C9C4}"/>
    <pc:docChg chg="custSel modSld">
      <pc:chgData name="Michael Greenwood" userId="add436ed-1825-4a16-a55d-7f910a9607be" providerId="ADAL" clId="{D687F9F5-4B73-4BCD-B806-99043288C9C4}" dt="2023-02-01T07:41:45.277" v="117" actId="1076"/>
      <pc:docMkLst>
        <pc:docMk/>
      </pc:docMkLst>
      <pc:sldChg chg="addSp delSp modSp mod">
        <pc:chgData name="Michael Greenwood" userId="add436ed-1825-4a16-a55d-7f910a9607be" providerId="ADAL" clId="{D687F9F5-4B73-4BCD-B806-99043288C9C4}" dt="2023-02-01T07:41:35.955" v="116" actId="1076"/>
        <pc:sldMkLst>
          <pc:docMk/>
          <pc:sldMk cId="3066318947" sldId="257"/>
        </pc:sldMkLst>
        <pc:spChg chg="del">
          <ac:chgData name="Michael Greenwood" userId="add436ed-1825-4a16-a55d-7f910a9607be" providerId="ADAL" clId="{D687F9F5-4B73-4BCD-B806-99043288C9C4}" dt="2023-02-01T07:40:20.873" v="0" actId="478"/>
          <ac:spMkLst>
            <pc:docMk/>
            <pc:sldMk cId="3066318947" sldId="257"/>
            <ac:spMk id="4" creationId="{F4D55758-CE9D-52DB-5FA9-0511D59BC172}"/>
          </ac:spMkLst>
        </pc:spChg>
        <pc:spChg chg="del">
          <ac:chgData name="Michael Greenwood" userId="add436ed-1825-4a16-a55d-7f910a9607be" providerId="ADAL" clId="{D687F9F5-4B73-4BCD-B806-99043288C9C4}" dt="2023-02-01T07:40:20.873" v="0" actId="478"/>
          <ac:spMkLst>
            <pc:docMk/>
            <pc:sldMk cId="3066318947" sldId="257"/>
            <ac:spMk id="5" creationId="{4FB12F9B-4BD2-1C50-C989-748F12815A2D}"/>
          </ac:spMkLst>
        </pc:spChg>
        <pc:spChg chg="del">
          <ac:chgData name="Michael Greenwood" userId="add436ed-1825-4a16-a55d-7f910a9607be" providerId="ADAL" clId="{D687F9F5-4B73-4BCD-B806-99043288C9C4}" dt="2023-02-01T07:40:31.832" v="2" actId="478"/>
          <ac:spMkLst>
            <pc:docMk/>
            <pc:sldMk cId="3066318947" sldId="257"/>
            <ac:spMk id="6" creationId="{2F6A343A-9EAF-5EF1-C0D9-BBF270F23FBD}"/>
          </ac:spMkLst>
        </pc:spChg>
        <pc:spChg chg="del">
          <ac:chgData name="Michael Greenwood" userId="add436ed-1825-4a16-a55d-7f910a9607be" providerId="ADAL" clId="{D687F9F5-4B73-4BCD-B806-99043288C9C4}" dt="2023-02-01T07:40:31.832" v="2" actId="478"/>
          <ac:spMkLst>
            <pc:docMk/>
            <pc:sldMk cId="3066318947" sldId="257"/>
            <ac:spMk id="7" creationId="{5187D226-1639-6D53-1645-93D5FD93FD9E}"/>
          </ac:spMkLst>
        </pc:spChg>
        <pc:spChg chg="del mod">
          <ac:chgData name="Michael Greenwood" userId="add436ed-1825-4a16-a55d-7f910a9607be" providerId="ADAL" clId="{D687F9F5-4B73-4BCD-B806-99043288C9C4}" dt="2023-02-01T07:40:34.918" v="4" actId="478"/>
          <ac:spMkLst>
            <pc:docMk/>
            <pc:sldMk cId="3066318947" sldId="257"/>
            <ac:spMk id="8" creationId="{F820BC6F-A182-6892-68C7-A2A0020B2A77}"/>
          </ac:spMkLst>
        </pc:spChg>
        <pc:spChg chg="del">
          <ac:chgData name="Michael Greenwood" userId="add436ed-1825-4a16-a55d-7f910a9607be" providerId="ADAL" clId="{D687F9F5-4B73-4BCD-B806-99043288C9C4}" dt="2023-02-01T07:40:25.024" v="1" actId="478"/>
          <ac:spMkLst>
            <pc:docMk/>
            <pc:sldMk cId="3066318947" sldId="257"/>
            <ac:spMk id="15" creationId="{4BD149A8-0EDA-5CC7-ADA5-C5C1C609A026}"/>
          </ac:spMkLst>
        </pc:spChg>
        <pc:graphicFrameChg chg="del">
          <ac:chgData name="Michael Greenwood" userId="add436ed-1825-4a16-a55d-7f910a9607be" providerId="ADAL" clId="{D687F9F5-4B73-4BCD-B806-99043288C9C4}" dt="2023-02-01T07:41:27.024" v="113" actId="478"/>
          <ac:graphicFrameMkLst>
            <pc:docMk/>
            <pc:sldMk cId="3066318947" sldId="257"/>
            <ac:graphicFrameMk id="16" creationId="{820897DA-E7C7-2F83-DB32-19C84B0F9E48}"/>
          </ac:graphicFrameMkLst>
        </pc:graphicFrameChg>
        <pc:graphicFrameChg chg="del">
          <ac:chgData name="Michael Greenwood" userId="add436ed-1825-4a16-a55d-7f910a9607be" providerId="ADAL" clId="{D687F9F5-4B73-4BCD-B806-99043288C9C4}" dt="2023-02-01T07:41:25.304" v="112" actId="478"/>
          <ac:graphicFrameMkLst>
            <pc:docMk/>
            <pc:sldMk cId="3066318947" sldId="257"/>
            <ac:graphicFrameMk id="17" creationId="{59A8BE11-E17E-40B9-ABE0-B665DA9BD022}"/>
          </ac:graphicFrameMkLst>
        </pc:graphicFrameChg>
        <pc:graphicFrameChg chg="del">
          <ac:chgData name="Michael Greenwood" userId="add436ed-1825-4a16-a55d-7f910a9607be" providerId="ADAL" clId="{D687F9F5-4B73-4BCD-B806-99043288C9C4}" dt="2023-02-01T07:41:28.425" v="114" actId="478"/>
          <ac:graphicFrameMkLst>
            <pc:docMk/>
            <pc:sldMk cId="3066318947" sldId="257"/>
            <ac:graphicFrameMk id="32" creationId="{CB410EAB-E640-08A9-BE56-D48C3A03199E}"/>
          </ac:graphicFrameMkLst>
        </pc:graphicFrameChg>
        <pc:graphicFrameChg chg="del mod">
          <ac:chgData name="Michael Greenwood" userId="add436ed-1825-4a16-a55d-7f910a9607be" providerId="ADAL" clId="{D687F9F5-4B73-4BCD-B806-99043288C9C4}" dt="2023-02-01T07:41:25.304" v="112" actId="478"/>
          <ac:graphicFrameMkLst>
            <pc:docMk/>
            <pc:sldMk cId="3066318947" sldId="257"/>
            <ac:graphicFrameMk id="34" creationId="{054EB029-5B45-E9C9-6123-FBF7925B33DD}"/>
          </ac:graphicFrameMkLst>
        </pc:graphicFrameChg>
        <pc:picChg chg="del">
          <ac:chgData name="Michael Greenwood" userId="add436ed-1825-4a16-a55d-7f910a9607be" providerId="ADAL" clId="{D687F9F5-4B73-4BCD-B806-99043288C9C4}" dt="2023-02-01T07:40:20.873" v="0" actId="478"/>
          <ac:picMkLst>
            <pc:docMk/>
            <pc:sldMk cId="3066318947" sldId="257"/>
            <ac:picMk id="2" creationId="{1941EE88-2312-90B6-84B8-1D32BC27C993}"/>
          </ac:picMkLst>
        </pc:picChg>
        <pc:picChg chg="del">
          <ac:chgData name="Michael Greenwood" userId="add436ed-1825-4a16-a55d-7f910a9607be" providerId="ADAL" clId="{D687F9F5-4B73-4BCD-B806-99043288C9C4}" dt="2023-02-01T07:40:20.873" v="0" actId="478"/>
          <ac:picMkLst>
            <pc:docMk/>
            <pc:sldMk cId="3066318947" sldId="257"/>
            <ac:picMk id="3" creationId="{EE0B6A2F-305C-E1D5-9FF3-10FB403E699B}"/>
          </ac:picMkLst>
        </pc:picChg>
        <pc:picChg chg="add mod">
          <ac:chgData name="Michael Greenwood" userId="add436ed-1825-4a16-a55d-7f910a9607be" providerId="ADAL" clId="{D687F9F5-4B73-4BCD-B806-99043288C9C4}" dt="2023-02-01T07:41:35.955" v="116" actId="1076"/>
          <ac:picMkLst>
            <pc:docMk/>
            <pc:sldMk cId="3066318947" sldId="257"/>
            <ac:picMk id="10" creationId="{46F3258B-9378-8367-ACD7-07FE31021ED4}"/>
          </ac:picMkLst>
        </pc:picChg>
        <pc:picChg chg="del">
          <ac:chgData name="Michael Greenwood" userId="add436ed-1825-4a16-a55d-7f910a9607be" providerId="ADAL" clId="{D687F9F5-4B73-4BCD-B806-99043288C9C4}" dt="2023-02-01T07:40:20.873" v="0" actId="478"/>
          <ac:picMkLst>
            <pc:docMk/>
            <pc:sldMk cId="3066318947" sldId="257"/>
            <ac:picMk id="22" creationId="{F1D76F69-0347-C9E8-074E-CBDC987ED0F2}"/>
          </ac:picMkLst>
        </pc:picChg>
        <pc:picChg chg="del">
          <ac:chgData name="Michael Greenwood" userId="add436ed-1825-4a16-a55d-7f910a9607be" providerId="ADAL" clId="{D687F9F5-4B73-4BCD-B806-99043288C9C4}" dt="2023-02-01T07:40:20.873" v="0" actId="478"/>
          <ac:picMkLst>
            <pc:docMk/>
            <pc:sldMk cId="3066318947" sldId="257"/>
            <ac:picMk id="23" creationId="{B9FCFCF4-FCB0-7DD5-A8C0-B78E0BDB36A4}"/>
          </ac:picMkLst>
        </pc:picChg>
      </pc:sldChg>
      <pc:sldChg chg="addSp delSp modSp mod">
        <pc:chgData name="Michael Greenwood" userId="add436ed-1825-4a16-a55d-7f910a9607be" providerId="ADAL" clId="{D687F9F5-4B73-4BCD-B806-99043288C9C4}" dt="2023-02-01T07:40:55.360" v="7" actId="1076"/>
        <pc:sldMkLst>
          <pc:docMk/>
          <pc:sldMk cId="3552318196" sldId="258"/>
        </pc:sldMkLst>
        <pc:graphicFrameChg chg="del">
          <ac:chgData name="Michael Greenwood" userId="add436ed-1825-4a16-a55d-7f910a9607be" providerId="ADAL" clId="{D687F9F5-4B73-4BCD-B806-99043288C9C4}" dt="2023-02-01T07:40:48.241" v="5" actId="478"/>
          <ac:graphicFrameMkLst>
            <pc:docMk/>
            <pc:sldMk cId="3552318196" sldId="258"/>
            <ac:graphicFrameMk id="2" creationId="{F367482E-ACD8-8219-C0C8-0331A463AC9D}"/>
          </ac:graphicFrameMkLst>
        </pc:graphicFrameChg>
        <pc:picChg chg="add mod">
          <ac:chgData name="Michael Greenwood" userId="add436ed-1825-4a16-a55d-7f910a9607be" providerId="ADAL" clId="{D687F9F5-4B73-4BCD-B806-99043288C9C4}" dt="2023-02-01T07:40:55.360" v="7" actId="1076"/>
          <ac:picMkLst>
            <pc:docMk/>
            <pc:sldMk cId="3552318196" sldId="258"/>
            <ac:picMk id="4" creationId="{2EA5E707-48F4-58B3-2927-71098103A889}"/>
          </ac:picMkLst>
        </pc:picChg>
      </pc:sldChg>
      <pc:sldChg chg="modSp mod">
        <pc:chgData name="Michael Greenwood" userId="add436ed-1825-4a16-a55d-7f910a9607be" providerId="ADAL" clId="{D687F9F5-4B73-4BCD-B806-99043288C9C4}" dt="2023-02-01T07:41:45.277" v="117" actId="1076"/>
        <pc:sldMkLst>
          <pc:docMk/>
          <pc:sldMk cId="2762088274" sldId="259"/>
        </pc:sldMkLst>
        <pc:picChg chg="mod">
          <ac:chgData name="Michael Greenwood" userId="add436ed-1825-4a16-a55d-7f910a9607be" providerId="ADAL" clId="{D687F9F5-4B73-4BCD-B806-99043288C9C4}" dt="2023-02-01T07:41:45.277" v="117" actId="1076"/>
          <ac:picMkLst>
            <pc:docMk/>
            <pc:sldMk cId="2762088274" sldId="259"/>
            <ac:picMk id="2" creationId="{9CF591DD-C21C-BD3C-ED80-0DE60EF8B2D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6539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282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320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414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03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79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102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449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3616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443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455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083663-C786-42DA-AA2E-1C18AC2C6150}" type="datetimeFigureOut">
              <a:rPr lang="en-US" smtClean="0"/>
              <a:t>2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679CC8-A85D-4421-8DB5-3DABAB4FD1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0917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CF591DD-C21C-BD3C-ED80-0DE60EF8B2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072" y="250447"/>
            <a:ext cx="6183824" cy="614137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7EC6739-B464-FE98-BEF9-BA6442BD8699}"/>
              </a:ext>
            </a:extLst>
          </p:cNvPr>
          <p:cNvSpPr txBox="1"/>
          <p:nvPr/>
        </p:nvSpPr>
        <p:spPr>
          <a:xfrm>
            <a:off x="369104" y="6616671"/>
            <a:ext cx="618382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l figure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1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Localisation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of GLP-1R expression in the SON.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Immunostaining of GLP-1R with AVP or OXT in SONs of control and 3-day WD animals. OC, optic chiasm. Scale bar = 100 µm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7620882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E8CBACE-C65B-AC90-4A67-E24B9F885B5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92" t="35126" r="6463" b="42527"/>
          <a:stretch/>
        </p:blipFill>
        <p:spPr>
          <a:xfrm flipH="1">
            <a:off x="1346567" y="1652479"/>
            <a:ext cx="3939616" cy="1532576"/>
          </a:xfrm>
          <a:prstGeom prst="rect">
            <a:avLst/>
          </a:prstGeom>
          <a:noFill/>
          <a:ln w="15875" cmpd="sng">
            <a:solidFill>
              <a:schemeClr val="tx1">
                <a:lumMod val="95000"/>
                <a:lumOff val="5000"/>
              </a:schemeClr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AE42A47-D469-05FD-8862-5007D73C4FF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94" t="56968" r="9227" b="36921"/>
          <a:stretch/>
        </p:blipFill>
        <p:spPr>
          <a:xfrm flipH="1">
            <a:off x="1337447" y="3265379"/>
            <a:ext cx="3948735" cy="419100"/>
          </a:xfrm>
          <a:prstGeom prst="rect">
            <a:avLst/>
          </a:prstGeom>
          <a:ln w="15875">
            <a:solidFill>
              <a:schemeClr val="tx1">
                <a:lumMod val="95000"/>
                <a:lumOff val="5000"/>
              </a:schemeClr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7058D93-E8A1-48F1-7746-7E2C34CF291B}"/>
              </a:ext>
            </a:extLst>
          </p:cNvPr>
          <p:cNvSpPr txBox="1"/>
          <p:nvPr/>
        </p:nvSpPr>
        <p:spPr>
          <a:xfrm>
            <a:off x="5260783" y="3305652"/>
            <a:ext cx="13305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ubulin</a:t>
            </a:r>
            <a:endParaRPr lang="en-GB" sz="16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1AE71D0-8C84-AF45-BD0D-BE66F0060AE4}"/>
              </a:ext>
            </a:extLst>
          </p:cNvPr>
          <p:cNvSpPr txBox="1"/>
          <p:nvPr/>
        </p:nvSpPr>
        <p:spPr>
          <a:xfrm>
            <a:off x="5270993" y="2125958"/>
            <a:ext cx="13305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GLP1R</a:t>
            </a:r>
            <a:endParaRPr lang="en-GB" sz="16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D3E3221-5D24-EE97-802E-ED09772C9723}"/>
              </a:ext>
            </a:extLst>
          </p:cNvPr>
          <p:cNvSpPr txBox="1"/>
          <p:nvPr/>
        </p:nvSpPr>
        <p:spPr>
          <a:xfrm>
            <a:off x="1568221" y="1074332"/>
            <a:ext cx="269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+</a:t>
            </a:r>
          </a:p>
          <a:p>
            <a:r>
              <a:rPr lang="en-US" b="1" dirty="0"/>
              <a:t>-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E3AA3BA-C175-FA79-E166-20C6C534957E}"/>
              </a:ext>
            </a:extLst>
          </p:cNvPr>
          <p:cNvSpPr txBox="1"/>
          <p:nvPr/>
        </p:nvSpPr>
        <p:spPr>
          <a:xfrm>
            <a:off x="466067" y="1132921"/>
            <a:ext cx="13305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Denatured</a:t>
            </a:r>
          </a:p>
          <a:p>
            <a:r>
              <a:rPr lang="en-US" sz="1400" b="1" dirty="0" err="1"/>
              <a:t>PNGase</a:t>
            </a:r>
            <a:r>
              <a:rPr lang="en-US" sz="1400" b="1" dirty="0"/>
              <a:t> F</a:t>
            </a:r>
            <a:endParaRPr lang="en-GB" sz="14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EF517E4-828D-394D-6E1F-C861BD4136C1}"/>
              </a:ext>
            </a:extLst>
          </p:cNvPr>
          <p:cNvSpPr txBox="1"/>
          <p:nvPr/>
        </p:nvSpPr>
        <p:spPr>
          <a:xfrm>
            <a:off x="1367678" y="867193"/>
            <a:ext cx="23375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tT20 pcDNA3.1-rGlp1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0699CF-3BD4-F625-DB76-DA90E4B5DF7F}"/>
              </a:ext>
            </a:extLst>
          </p:cNvPr>
          <p:cNvSpPr txBox="1"/>
          <p:nvPr/>
        </p:nvSpPr>
        <p:spPr>
          <a:xfrm>
            <a:off x="3415958" y="844757"/>
            <a:ext cx="25657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/>
              <a:t>Neurointermediate</a:t>
            </a:r>
            <a:r>
              <a:rPr lang="en-US" sz="1600" b="1" dirty="0"/>
              <a:t>  lobe</a:t>
            </a:r>
            <a:endParaRPr lang="en-GB" sz="16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D5E916C-A041-BE65-F4BC-476F874B9685}"/>
              </a:ext>
            </a:extLst>
          </p:cNvPr>
          <p:cNvSpPr txBox="1"/>
          <p:nvPr/>
        </p:nvSpPr>
        <p:spPr>
          <a:xfrm>
            <a:off x="2025421" y="1074332"/>
            <a:ext cx="269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+</a:t>
            </a:r>
          </a:p>
          <a:p>
            <a:r>
              <a:rPr lang="en-US" b="1" dirty="0"/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9F24294-8E99-36C3-EF8F-E64FB03B1F40}"/>
              </a:ext>
            </a:extLst>
          </p:cNvPr>
          <p:cNvSpPr txBox="1"/>
          <p:nvPr/>
        </p:nvSpPr>
        <p:spPr>
          <a:xfrm>
            <a:off x="2419121" y="1074332"/>
            <a:ext cx="269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-</a:t>
            </a:r>
          </a:p>
          <a:p>
            <a:r>
              <a:rPr lang="en-US" b="1" dirty="0"/>
              <a:t>-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B04F410-5849-B7FE-5A6E-DA54B74200A7}"/>
              </a:ext>
            </a:extLst>
          </p:cNvPr>
          <p:cNvSpPr txBox="1"/>
          <p:nvPr/>
        </p:nvSpPr>
        <p:spPr>
          <a:xfrm>
            <a:off x="2812821" y="1074332"/>
            <a:ext cx="269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-</a:t>
            </a:r>
          </a:p>
          <a:p>
            <a:r>
              <a:rPr lang="en-US" b="1" dirty="0"/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83BD04B-6662-4BAC-994D-885BFF8A2687}"/>
              </a:ext>
            </a:extLst>
          </p:cNvPr>
          <p:cNvSpPr txBox="1"/>
          <p:nvPr/>
        </p:nvSpPr>
        <p:spPr>
          <a:xfrm>
            <a:off x="3612921" y="1074332"/>
            <a:ext cx="269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+</a:t>
            </a:r>
          </a:p>
          <a:p>
            <a:r>
              <a:rPr lang="en-US" b="1" dirty="0"/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39334ED-FA17-54AA-2E0E-1D3CAD850B89}"/>
              </a:ext>
            </a:extLst>
          </p:cNvPr>
          <p:cNvSpPr txBox="1"/>
          <p:nvPr/>
        </p:nvSpPr>
        <p:spPr>
          <a:xfrm>
            <a:off x="4044721" y="1074332"/>
            <a:ext cx="269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+</a:t>
            </a:r>
          </a:p>
          <a:p>
            <a:r>
              <a:rPr lang="en-US" b="1" dirty="0"/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1984DF-194E-FAE9-81FC-50586588BE2A}"/>
              </a:ext>
            </a:extLst>
          </p:cNvPr>
          <p:cNvSpPr txBox="1"/>
          <p:nvPr/>
        </p:nvSpPr>
        <p:spPr>
          <a:xfrm>
            <a:off x="4451121" y="1074332"/>
            <a:ext cx="269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-</a:t>
            </a:r>
          </a:p>
          <a:p>
            <a:r>
              <a:rPr lang="en-US" b="1" dirty="0"/>
              <a:t>-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F03457E-1D4A-E0F2-20FC-B48C9C212647}"/>
              </a:ext>
            </a:extLst>
          </p:cNvPr>
          <p:cNvSpPr txBox="1"/>
          <p:nvPr/>
        </p:nvSpPr>
        <p:spPr>
          <a:xfrm>
            <a:off x="4844821" y="1074332"/>
            <a:ext cx="2691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-</a:t>
            </a:r>
          </a:p>
          <a:p>
            <a:r>
              <a:rPr lang="en-US" b="1" dirty="0"/>
              <a:t>+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03D886AB-ED0E-C908-CEE6-0CABFA2888CE}"/>
              </a:ext>
            </a:extLst>
          </p:cNvPr>
          <p:cNvCxnSpPr/>
          <p:nvPr/>
        </p:nvCxnSpPr>
        <p:spPr>
          <a:xfrm flipH="1">
            <a:off x="1440704" y="1136582"/>
            <a:ext cx="176267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F3598CB5-00D2-2CE3-2F01-702193DDB9EB}"/>
              </a:ext>
            </a:extLst>
          </p:cNvPr>
          <p:cNvCxnSpPr/>
          <p:nvPr/>
        </p:nvCxnSpPr>
        <p:spPr>
          <a:xfrm flipH="1">
            <a:off x="3498104" y="1136582"/>
            <a:ext cx="176267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46F85556-0F0D-68C3-918D-868F3E351012}"/>
              </a:ext>
            </a:extLst>
          </p:cNvPr>
          <p:cNvCxnSpPr/>
          <p:nvPr/>
        </p:nvCxnSpPr>
        <p:spPr>
          <a:xfrm>
            <a:off x="1222054" y="2750014"/>
            <a:ext cx="914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7C831E7-2370-DA14-3931-075DAD144928}"/>
              </a:ext>
            </a:extLst>
          </p:cNvPr>
          <p:cNvCxnSpPr/>
          <p:nvPr/>
        </p:nvCxnSpPr>
        <p:spPr>
          <a:xfrm>
            <a:off x="1222054" y="2508714"/>
            <a:ext cx="914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18CA005-95D0-CCA1-91DE-69634DCB342A}"/>
              </a:ext>
            </a:extLst>
          </p:cNvPr>
          <p:cNvCxnSpPr/>
          <p:nvPr/>
        </p:nvCxnSpPr>
        <p:spPr>
          <a:xfrm>
            <a:off x="1222054" y="2038814"/>
            <a:ext cx="9144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B0EC2B44-AA3C-4A68-A062-A8E3D094FF25}"/>
              </a:ext>
            </a:extLst>
          </p:cNvPr>
          <p:cNvSpPr txBox="1"/>
          <p:nvPr/>
        </p:nvSpPr>
        <p:spPr>
          <a:xfrm>
            <a:off x="864646" y="2566879"/>
            <a:ext cx="6652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40</a:t>
            </a:r>
            <a:endParaRPr lang="en-GB" sz="1600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E812CFA-0765-0164-BFBA-0B0AB6AF3E0D}"/>
              </a:ext>
            </a:extLst>
          </p:cNvPr>
          <p:cNvSpPr txBox="1"/>
          <p:nvPr/>
        </p:nvSpPr>
        <p:spPr>
          <a:xfrm>
            <a:off x="864646" y="2325579"/>
            <a:ext cx="6652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50</a:t>
            </a:r>
            <a:endParaRPr lang="en-GB" sz="16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B93F826-A2A2-5099-21AC-F61D5A9C09B2}"/>
              </a:ext>
            </a:extLst>
          </p:cNvPr>
          <p:cNvSpPr txBox="1"/>
          <p:nvPr/>
        </p:nvSpPr>
        <p:spPr>
          <a:xfrm>
            <a:off x="864646" y="1855679"/>
            <a:ext cx="6652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60</a:t>
            </a:r>
            <a:endParaRPr lang="en-GB" sz="1600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E70B2E9-3482-9BCF-4607-3B8526FDF2A5}"/>
              </a:ext>
            </a:extLst>
          </p:cNvPr>
          <p:cNvSpPr txBox="1"/>
          <p:nvPr/>
        </p:nvSpPr>
        <p:spPr>
          <a:xfrm>
            <a:off x="851946" y="1563579"/>
            <a:ext cx="5714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/>
              <a:t>kDa</a:t>
            </a:r>
            <a:endParaRPr lang="en-GB" sz="16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C4CF7EA-FA4F-83E4-9B14-680AF1821D47}"/>
              </a:ext>
            </a:extLst>
          </p:cNvPr>
          <p:cNvSpPr txBox="1"/>
          <p:nvPr/>
        </p:nvSpPr>
        <p:spPr>
          <a:xfrm>
            <a:off x="263213" y="3885069"/>
            <a:ext cx="6381426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GLP-1R is known to undergo N-linked glycosylation. We investigated the glycosylation status of this receptor in AtT20 cells transiently expressing the rat GLP-1R as well as looking at endogenous GLP-1R expression in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urointermedia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obe by western blotting. To remove N-linked oligosaccharides we us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NGase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ccording to the suppliers' instructions (New Engl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Lab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P0704S).  When the reactions were performed under denaturing conditions no GLP-1R immunoreactive bands were present in either AtT20 cells or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urointermedia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obe. In non-denaturing reaction conditions immunoreactive bands were seen in AtT20 cells and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urointermedia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obe. The treatment with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NGas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 lowered the molecular mass of GLP-1R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oreactiv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bands in both AtT20 cells and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urointermedia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obe. Tubulin was used as a loading control.</a:t>
            </a:r>
          </a:p>
        </p:txBody>
      </p:sp>
    </p:spTree>
    <p:extLst>
      <p:ext uri="{BB962C8B-B14F-4D97-AF65-F5344CB8AC3E}">
        <p14:creationId xmlns:p14="http://schemas.microsoft.com/office/powerpoint/2010/main" val="42411837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7348D1F2-A041-D925-BCEC-0C4F828257B8}"/>
              </a:ext>
            </a:extLst>
          </p:cNvPr>
          <p:cNvSpPr txBox="1"/>
          <p:nvPr/>
        </p:nvSpPr>
        <p:spPr>
          <a:xfrm>
            <a:off x="176957" y="4279473"/>
            <a:ext cx="650408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creased ERK phosphorylation in the water depriv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urointermedia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obe and supraoptic nucleu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western blot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total ERK expression in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urointermedia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obes of 3-day water deprived rats compared to control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densitometry analysis of band intensities in control and water depriv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urointermedia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obe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determined using Quantity On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western blot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total ERK expression in supraoptic nuclei of 3-day water deprived rats compared to control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densitometry analysis of band intensities in control and water deprive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eurointermedia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lobes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determined using Quantity On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, anterior pituitary sample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alues are means +SEM of n = 5 - 6 animals per group. *p ≤ 0.05, **p ≤ 0.0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45C6563-173A-8E60-C6BE-BE997C48837E}"/>
              </a:ext>
            </a:extLst>
          </p:cNvPr>
          <p:cNvSpPr txBox="1"/>
          <p:nvPr/>
        </p:nvSpPr>
        <p:spPr>
          <a:xfrm>
            <a:off x="3247987" y="1351076"/>
            <a:ext cx="13305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lang="en-GB" sz="105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F82B2E3-5146-B5B8-FF5B-10D3EC15A040}"/>
              </a:ext>
            </a:extLst>
          </p:cNvPr>
          <p:cNvSpPr txBox="1"/>
          <p:nvPr/>
        </p:nvSpPr>
        <p:spPr>
          <a:xfrm>
            <a:off x="3285565" y="1711597"/>
            <a:ext cx="13305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tERK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16EC6F89-1B5E-921D-E306-FE55EB4D61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975" y="193658"/>
            <a:ext cx="3269293" cy="1839159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60D32C72-1995-C70C-14BC-0EECAF54688B}"/>
              </a:ext>
            </a:extLst>
          </p:cNvPr>
          <p:cNvSpPr txBox="1"/>
          <p:nvPr/>
        </p:nvSpPr>
        <p:spPr>
          <a:xfrm>
            <a:off x="134709" y="557213"/>
            <a:ext cx="604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19E0F96-D834-54A4-1CF8-9FA9478D6D7F}"/>
              </a:ext>
            </a:extLst>
          </p:cNvPr>
          <p:cNvSpPr txBox="1"/>
          <p:nvPr/>
        </p:nvSpPr>
        <p:spPr>
          <a:xfrm>
            <a:off x="3932175" y="557213"/>
            <a:ext cx="604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29D983B4-40B7-2F5E-F031-6393B1A32368}"/>
              </a:ext>
            </a:extLst>
          </p:cNvPr>
          <p:cNvGrpSpPr/>
          <p:nvPr/>
        </p:nvGrpSpPr>
        <p:grpSpPr>
          <a:xfrm>
            <a:off x="489858" y="2923240"/>
            <a:ext cx="2775856" cy="542257"/>
            <a:chOff x="413017" y="2539040"/>
            <a:chExt cx="3950445" cy="940388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335E3CB9-669A-DD69-20EA-D3212791C9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0260" t="45927" r="14868" b="42791"/>
            <a:stretch/>
          </p:blipFill>
          <p:spPr>
            <a:xfrm flipH="1">
              <a:off x="421159" y="2539040"/>
              <a:ext cx="3942303" cy="462141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71E2B6FC-01B0-932A-52F0-ACF5EC6E1D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365" t="16151" r="16970" b="74356"/>
            <a:stretch/>
          </p:blipFill>
          <p:spPr>
            <a:xfrm flipH="1">
              <a:off x="413017" y="3089239"/>
              <a:ext cx="3945544" cy="39018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AB50DBCD-6446-9A99-C617-3DE34350A72A}"/>
              </a:ext>
            </a:extLst>
          </p:cNvPr>
          <p:cNvSpPr txBox="1"/>
          <p:nvPr/>
        </p:nvSpPr>
        <p:spPr>
          <a:xfrm>
            <a:off x="3300495" y="2901964"/>
            <a:ext cx="13305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endParaRPr lang="en-GB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FB7C47A-B5B6-7A48-DB7E-F9E63E2AF8DC}"/>
              </a:ext>
            </a:extLst>
          </p:cNvPr>
          <p:cNvSpPr txBox="1"/>
          <p:nvPr/>
        </p:nvSpPr>
        <p:spPr>
          <a:xfrm>
            <a:off x="3318271" y="3227532"/>
            <a:ext cx="13305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tERK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236AD1A-8636-5115-574E-6A1097FFC635}"/>
              </a:ext>
            </a:extLst>
          </p:cNvPr>
          <p:cNvSpPr txBox="1"/>
          <p:nvPr/>
        </p:nvSpPr>
        <p:spPr>
          <a:xfrm>
            <a:off x="134709" y="2233583"/>
            <a:ext cx="604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E93C186-E353-EDFD-7FE8-5A43D473A925}"/>
              </a:ext>
            </a:extLst>
          </p:cNvPr>
          <p:cNvSpPr txBox="1"/>
          <p:nvPr/>
        </p:nvSpPr>
        <p:spPr>
          <a:xfrm>
            <a:off x="3930895" y="2192625"/>
            <a:ext cx="604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3ECFF91C-A859-F56B-C6E2-5EF5D4212A77}"/>
              </a:ext>
            </a:extLst>
          </p:cNvPr>
          <p:cNvCxnSpPr/>
          <p:nvPr/>
        </p:nvCxnSpPr>
        <p:spPr>
          <a:xfrm>
            <a:off x="560935" y="2866144"/>
            <a:ext cx="132165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8B8BACA7-D64E-E773-BFE8-921B291E7EF0}"/>
              </a:ext>
            </a:extLst>
          </p:cNvPr>
          <p:cNvCxnSpPr/>
          <p:nvPr/>
        </p:nvCxnSpPr>
        <p:spPr>
          <a:xfrm>
            <a:off x="1919723" y="2864864"/>
            <a:ext cx="1321653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B32023B0-7B86-04A4-C856-B3D96DB7E8CC}"/>
              </a:ext>
            </a:extLst>
          </p:cNvPr>
          <p:cNvSpPr txBox="1"/>
          <p:nvPr/>
        </p:nvSpPr>
        <p:spPr>
          <a:xfrm>
            <a:off x="875643" y="2676608"/>
            <a:ext cx="19661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Control</a:t>
            </a:r>
            <a:endParaRPr lang="en-GB" sz="900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30D6D91A-6449-63FE-3BB3-D951B16E903C}"/>
              </a:ext>
            </a:extLst>
          </p:cNvPr>
          <p:cNvSpPr txBox="1"/>
          <p:nvPr/>
        </p:nvSpPr>
        <p:spPr>
          <a:xfrm>
            <a:off x="1935675" y="2675796"/>
            <a:ext cx="23178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3d water deprivation</a:t>
            </a:r>
            <a:endParaRPr lang="en-GB" sz="900" b="1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46F3258B-9378-8367-ACD7-07FE31021E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08411" y="750741"/>
            <a:ext cx="2188654" cy="32067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63189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D240DA4-F30F-38AE-E701-04A74495CC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6959" y="1406240"/>
            <a:ext cx="5870957" cy="188992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C7DEDAE-8AB8-C7C5-7FC1-DD103E272E99}"/>
              </a:ext>
            </a:extLst>
          </p:cNvPr>
          <p:cNvSpPr txBox="1"/>
          <p:nvPr/>
        </p:nvSpPr>
        <p:spPr>
          <a:xfrm>
            <a:off x="191269" y="1085117"/>
            <a:ext cx="604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3499D10-BF4A-DF80-271D-A1386A544ADC}"/>
              </a:ext>
            </a:extLst>
          </p:cNvPr>
          <p:cNvSpPr txBox="1"/>
          <p:nvPr/>
        </p:nvSpPr>
        <p:spPr>
          <a:xfrm>
            <a:off x="2313870" y="1086686"/>
            <a:ext cx="604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040E621-F0B4-5ECD-7053-D1D714A1D191}"/>
              </a:ext>
            </a:extLst>
          </p:cNvPr>
          <p:cNvSpPr txBox="1"/>
          <p:nvPr/>
        </p:nvSpPr>
        <p:spPr>
          <a:xfrm>
            <a:off x="191269" y="3459341"/>
            <a:ext cx="650408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hosphorylated ERK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expression in the posterior pituitary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localisat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pituicyte marker S100B in the rat posterior pituitary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mmunolocalisati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GFP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 the posterior </a:t>
            </a:r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pituitary of 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at injected in a single SON with a viral vector expressing a specific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lp1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hRNA. White arrows mark selected GFP positive nerve terminals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cale bars = 10 µm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94454134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AB103E8-84D1-C8CF-D253-ADA40AFB17E7}"/>
              </a:ext>
            </a:extLst>
          </p:cNvPr>
          <p:cNvSpPr txBox="1"/>
          <p:nvPr/>
        </p:nvSpPr>
        <p:spPr>
          <a:xfrm>
            <a:off x="176957" y="3440233"/>
            <a:ext cx="65040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5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anges to body weight during water deprivation in control and liraglutide treated animals. </a:t>
            </a:r>
            <a:r>
              <a:rPr lang="en-GB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alues are means +SEM of n = 4 - 6 animals per grou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EA5E707-48F4-58B3-2927-71098103A8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2030" y="427285"/>
            <a:ext cx="4014216" cy="30129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2318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53</Words>
  <Application>Microsoft Office PowerPoint</Application>
  <PresentationFormat>A4 Paper (210x297 mm)</PresentationFormat>
  <Paragraphs>4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reenwood</dc:creator>
  <cp:lastModifiedBy>Michael Greenwood</cp:lastModifiedBy>
  <cp:revision>1</cp:revision>
  <dcterms:created xsi:type="dcterms:W3CDTF">2022-09-30T06:51:41Z</dcterms:created>
  <dcterms:modified xsi:type="dcterms:W3CDTF">2023-02-01T07:41:54Z</dcterms:modified>
</cp:coreProperties>
</file>